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9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13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8F49343-63E0-4161-9B07-5129FFDE2107}"/>
              </a:ext>
            </a:extLst>
          </p:cNvPr>
          <p:cNvSpPr txBox="1"/>
          <p:nvPr/>
        </p:nvSpPr>
        <p:spPr>
          <a:xfrm>
            <a:off x="5643" y="52723"/>
            <a:ext cx="9144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1" dirty="0">
                <a:latin typeface="+mn-lt"/>
              </a:rPr>
              <a:t>Figure S7. Additional </a:t>
            </a:r>
            <a:r>
              <a:rPr lang="en-GB" sz="1400" b="1" i="1" dirty="0">
                <a:latin typeface="+mn-lt"/>
              </a:rPr>
              <a:t>in vivo </a:t>
            </a:r>
            <a:r>
              <a:rPr lang="en-GB" sz="1400" b="1" dirty="0">
                <a:latin typeface="+mn-lt"/>
              </a:rPr>
              <a:t>PD data. (Refers to Figure 5)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E36738-B7D1-4445-8C40-E4EE449564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560" y="624380"/>
            <a:ext cx="3415612" cy="3407454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4E076A9-E47D-4976-8936-64492F5D5D59}"/>
              </a:ext>
            </a:extLst>
          </p:cNvPr>
          <p:cNvSpPr txBox="1"/>
          <p:nvPr/>
        </p:nvSpPr>
        <p:spPr>
          <a:xfrm>
            <a:off x="57256" y="5717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1FCE93E-5CCA-46E6-9A5E-8E0462A6D1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2080" y="836712"/>
            <a:ext cx="2547534" cy="2421038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A4D7D23-11AE-410C-991A-67572C995921}"/>
              </a:ext>
            </a:extLst>
          </p:cNvPr>
          <p:cNvSpPr txBox="1"/>
          <p:nvPr/>
        </p:nvSpPr>
        <p:spPr>
          <a:xfrm>
            <a:off x="5076056" y="5717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21A5F80-698A-45CF-9EB6-459E9329EDC2}"/>
              </a:ext>
            </a:extLst>
          </p:cNvPr>
          <p:cNvSpPr txBox="1"/>
          <p:nvPr/>
        </p:nvSpPr>
        <p:spPr>
          <a:xfrm>
            <a:off x="110282" y="393305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29042EA-110A-457E-801E-F6F3019690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1560" y="4295715"/>
            <a:ext cx="3415611" cy="2363074"/>
          </a:xfrm>
          <a:prstGeom prst="rect">
            <a:avLst/>
          </a:prstGeom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9307E4F-8323-6128-B161-936D71A89D4A}"/>
              </a:ext>
            </a:extLst>
          </p:cNvPr>
          <p:cNvSpPr txBox="1"/>
          <p:nvPr/>
        </p:nvSpPr>
        <p:spPr>
          <a:xfrm>
            <a:off x="4644007" y="4281559"/>
            <a:ext cx="4320481" cy="1728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7. Additional </a:t>
            </a:r>
            <a:r>
              <a:rPr lang="en-GB" sz="1000" b="1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in vivo </a:t>
            </a:r>
            <a:r>
              <a:rPr lang="en-GB" sz="10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PD data from models of TCL. (Refers to Figure 5)</a:t>
            </a:r>
            <a:endParaRPr lang="en-GB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Scatter blots for 4 chemokines (KC-GRO, IP-10, MIP-2, and MCP-1) from the Luminex data from mouse plasma samples taken at day 5 (2 h post final dose) from the BW5147 tumor-bearing syngeneic mouse PD model. 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HMGB1 ELISA data from mouse plasma samples taken at day 5 (2 h post final dose) from the BW5147 tumor-bearing syngeneic mouse PD model.</a:t>
            </a:r>
          </a:p>
          <a:p>
            <a:pPr marL="228600" indent="-228600" algn="just" fontAlgn="base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Comparison of mouse plasma IP-10 levels (measured by MSD assay) with tumor IP-10 mRNA levels (measured by qPCR). </a:t>
            </a:r>
            <a:endParaRPr lang="en-GB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1374960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09</TotalTime>
  <Words>13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Astex Pharmaceuticals PowerPoint Template US_061113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2</cp:revision>
  <cp:lastPrinted>2020-03-10T12:57:33Z</cp:lastPrinted>
  <dcterms:created xsi:type="dcterms:W3CDTF">2018-10-12T15:56:46Z</dcterms:created>
  <dcterms:modified xsi:type="dcterms:W3CDTF">2024-02-13T11:10:01Z</dcterms:modified>
</cp:coreProperties>
</file>